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507" r:id="rId2"/>
  </p:sldIdLst>
  <p:sldSz cx="121920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869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173" autoAdjust="0"/>
    <p:restoredTop sz="74510" autoAdjust="0"/>
  </p:normalViewPr>
  <p:slideViewPr>
    <p:cSldViewPr snapToGrid="0">
      <p:cViewPr varScale="1">
        <p:scale>
          <a:sx n="61" d="100"/>
          <a:sy n="61" d="100"/>
        </p:scale>
        <p:origin x="2670" y="66"/>
      </p:cViewPr>
      <p:guideLst/>
    </p:cSldViewPr>
  </p:slideViewPr>
  <p:notesTextViewPr>
    <p:cViewPr>
      <p:scale>
        <a:sx n="125" d="100"/>
        <a:sy n="125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28B7A6-A418-4C37-8DE7-370EEF89986F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F0C8CD-7C34-44D0-AB1A-3784C53859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02208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5CFC143-E7DD-E595-7666-54311193AA6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77907356-5E1F-9FCA-A1B7-83A033E7C706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4C55345D-9849-86E2-6BC5-A8FB8FF20AE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0" algn="just" defTabSz="914400">
              <a:defRPr/>
            </a:pP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</a:rPr>
              <a:t>Fig. S3: Baseline cytokine secretion in vehicle-treated PBMCs</a:t>
            </a:r>
            <a:r>
              <a:rPr lang="en-US" sz="1200" kern="100">
                <a:solidFill>
                  <a:srgbClr val="FF0000"/>
                </a:solidFill>
                <a:latin typeface="Arial" panose="020B0604020202020204" pitchFamily="34" charset="0"/>
                <a:ea typeface="Aptos" panose="020B0004020202020204" pitchFamily="34" charset="0"/>
              </a:rPr>
              <a:t>. 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ar graphs overlaid with scatter plots showing secretion of inflammatory cytokines from unstimulated PBMCs after 24h from NHCs, iPD patients, 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LRRK2-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D patients, and 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BA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-PD patients. (</a:t>
            </a: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Secretion of IFN‐</a:t>
            </a:r>
            <a:r>
              <a:rPr lang="el-GR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γ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(Cohort 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5862). (</a:t>
            </a: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Secretion of IL-10 (Cohort 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7260). (</a:t>
            </a: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Secretion of IL-12p70 (Cohort 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0377). (</a:t>
            </a: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D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Secretion of IL-13 (Cohort 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8943). (</a:t>
            </a: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E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Secretion of IL-1β (Cohort 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2654). (</a:t>
            </a: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Secretion of IL-2 (Cohort 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3061). (</a:t>
            </a: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Secretion of IL-4 (Cohort 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1340). (</a:t>
            </a: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H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Secretion of IL-6 (Cohort 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0559). (</a:t>
            </a: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Secretion of IL-8 (Cohort 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6352). (</a:t>
            </a: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J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Secretion of TNF (Cohort 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2755). Bars represent mean +/- SEM. NHCs, 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 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= 35; iPD, 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28; 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LRRK2-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D, 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11; 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BA-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D, 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16. Each symbol represents the measurement from a single individual. The results in A-J were analyzed using one-way ANOVA with Tukey’s corrections for multiple comparisons. Statistically significant differences between cohorts defined by 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&lt; 0.05 are shown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endParaRPr lang="en-US" sz="1200" kern="100" dirty="0">
              <a:latin typeface="Arial" panose="020B06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0217DC2-6405-354F-37C6-A6EE60EFBB2B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F0C8CD-7C34-44D0-AB1A-3784C538593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343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96484"/>
            <a:ext cx="103632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802717"/>
            <a:ext cx="91440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18789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03859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86834"/>
            <a:ext cx="2628900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86834"/>
            <a:ext cx="7734300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7986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119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79653"/>
            <a:ext cx="1051560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119286"/>
            <a:ext cx="1051560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82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82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52605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1960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86836"/>
            <a:ext cx="1051560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241551"/>
            <a:ext cx="5157787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340100"/>
            <a:ext cx="5157787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241551"/>
            <a:ext cx="5183188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340100"/>
            <a:ext cx="5183188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5141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437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20777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316569"/>
            <a:ext cx="6172200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98131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316569"/>
            <a:ext cx="6172200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11749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86836"/>
            <a:ext cx="105156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434167"/>
            <a:ext cx="105156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475136"/>
            <a:ext cx="411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59441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17E08DC-1F84-42D3-FE5E-31B303B9B3F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22">
            <a:extLst>
              <a:ext uri="{FF2B5EF4-FFF2-40B4-BE49-F238E27FC236}">
                <a16:creationId xmlns:a16="http://schemas.microsoft.com/office/drawing/2014/main" id="{CE83C027-210E-75D1-71AF-5940BD8A36E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3783" y="3636510"/>
            <a:ext cx="2330450" cy="2876550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7FB69651-47AE-D111-D92B-D204C48187D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09221" y="3630160"/>
            <a:ext cx="2482850" cy="288925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2CE0E426-E219-F2D8-8C33-7845363DD67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54928" y="3630160"/>
            <a:ext cx="2209800" cy="288925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89724B3C-DAFB-A5AC-9392-B62DAD73525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313587" y="3630160"/>
            <a:ext cx="2444750" cy="2889250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CFBE73F5-24C3-76EB-6EAE-56AFEB94607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409723" y="3642860"/>
            <a:ext cx="2209800" cy="287655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9A205B0C-C010-95B5-4382-5B4FCB87229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24546" y="552814"/>
            <a:ext cx="2209800" cy="287655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AE4B7F26-64B1-E903-2891-E18F92A2871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196783" y="569765"/>
            <a:ext cx="2330450" cy="286385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2741BDCC-5E6F-590C-A52D-0D9A8BB5C92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248915" y="549131"/>
            <a:ext cx="2330450" cy="288925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7195BE76-9CC6-A103-2B0E-FA841CC7268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321950" y="542781"/>
            <a:ext cx="2209800" cy="288925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03B4983C-3E1E-048F-7C83-15BFF1A4C0C5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415092" y="555481"/>
            <a:ext cx="2330450" cy="2876550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BB0A7030-2770-B9E9-96E7-167214D50618}"/>
              </a:ext>
            </a:extLst>
          </p:cNvPr>
          <p:cNvSpPr txBox="1"/>
          <p:nvPr/>
        </p:nvSpPr>
        <p:spPr>
          <a:xfrm>
            <a:off x="183174" y="589184"/>
            <a:ext cx="3432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10387A3-75DC-3083-834A-FB9F91D419DA}"/>
              </a:ext>
            </a:extLst>
          </p:cNvPr>
          <p:cNvSpPr txBox="1"/>
          <p:nvPr/>
        </p:nvSpPr>
        <p:spPr>
          <a:xfrm>
            <a:off x="2246743" y="589843"/>
            <a:ext cx="3432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525A03C-6F14-4723-6EA4-6FF4E128EB1B}"/>
              </a:ext>
            </a:extLst>
          </p:cNvPr>
          <p:cNvSpPr txBox="1"/>
          <p:nvPr/>
        </p:nvSpPr>
        <p:spPr>
          <a:xfrm>
            <a:off x="4301004" y="591167"/>
            <a:ext cx="3432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6E0D903-949E-51B1-95A9-F4706A572C04}"/>
              </a:ext>
            </a:extLst>
          </p:cNvPr>
          <p:cNvSpPr txBox="1"/>
          <p:nvPr/>
        </p:nvSpPr>
        <p:spPr>
          <a:xfrm>
            <a:off x="6369713" y="590532"/>
            <a:ext cx="3432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D9A1927-9620-0B6B-B10C-2FBAB5FDE8B9}"/>
              </a:ext>
            </a:extLst>
          </p:cNvPr>
          <p:cNvSpPr txBox="1"/>
          <p:nvPr/>
        </p:nvSpPr>
        <p:spPr>
          <a:xfrm>
            <a:off x="8460759" y="586038"/>
            <a:ext cx="3432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798D281-97AC-81C6-C940-391F80CA840C}"/>
              </a:ext>
            </a:extLst>
          </p:cNvPr>
          <p:cNvSpPr txBox="1"/>
          <p:nvPr/>
        </p:nvSpPr>
        <p:spPr>
          <a:xfrm>
            <a:off x="185519" y="3684714"/>
            <a:ext cx="3432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BD0D38E-3787-2CAB-2544-68D663131972}"/>
              </a:ext>
            </a:extLst>
          </p:cNvPr>
          <p:cNvSpPr txBox="1"/>
          <p:nvPr/>
        </p:nvSpPr>
        <p:spPr>
          <a:xfrm>
            <a:off x="2249088" y="3685373"/>
            <a:ext cx="3432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BF030A2-52EF-6B16-9562-8F03D6EBD54D}"/>
              </a:ext>
            </a:extLst>
          </p:cNvPr>
          <p:cNvSpPr txBox="1"/>
          <p:nvPr/>
        </p:nvSpPr>
        <p:spPr>
          <a:xfrm>
            <a:off x="4303349" y="3686697"/>
            <a:ext cx="3432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30366AE-BE8E-01A7-8B9C-55BAE82CB09F}"/>
              </a:ext>
            </a:extLst>
          </p:cNvPr>
          <p:cNvSpPr txBox="1"/>
          <p:nvPr/>
        </p:nvSpPr>
        <p:spPr>
          <a:xfrm>
            <a:off x="6372058" y="3686062"/>
            <a:ext cx="3432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F1C108F-483E-1E43-855D-9E6E2478F91C}"/>
              </a:ext>
            </a:extLst>
          </p:cNvPr>
          <p:cNvSpPr txBox="1"/>
          <p:nvPr/>
        </p:nvSpPr>
        <p:spPr>
          <a:xfrm>
            <a:off x="8463104" y="3681568"/>
            <a:ext cx="3432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B61512BA-E42E-11D8-9889-9303D706EB40}"/>
              </a:ext>
            </a:extLst>
          </p:cNvPr>
          <p:cNvGrpSpPr/>
          <p:nvPr/>
        </p:nvGrpSpPr>
        <p:grpSpPr>
          <a:xfrm>
            <a:off x="6963330" y="927189"/>
            <a:ext cx="1029971" cy="485564"/>
            <a:chOff x="778513" y="2135719"/>
            <a:chExt cx="1029971" cy="485564"/>
          </a:xfrm>
        </p:grpSpPr>
        <p:sp>
          <p:nvSpPr>
            <p:cNvPr id="8" name="Right Brace 7">
              <a:extLst>
                <a:ext uri="{FF2B5EF4-FFF2-40B4-BE49-F238E27FC236}">
                  <a16:creationId xmlns:a16="http://schemas.microsoft.com/office/drawing/2014/main" id="{D929AC8B-8A58-2DF0-CE13-07D95E9CFAA8}"/>
                </a:ext>
              </a:extLst>
            </p:cNvPr>
            <p:cNvSpPr/>
            <p:nvPr/>
          </p:nvSpPr>
          <p:spPr>
            <a:xfrm rot="16200000">
              <a:off x="1161247" y="1974045"/>
              <a:ext cx="264504" cy="1029971"/>
            </a:xfrm>
            <a:prstGeom prst="rightBrace">
              <a:avLst>
                <a:gd name="adj1" fmla="val 77381"/>
                <a:gd name="adj2" fmla="val 50000"/>
              </a:avLst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F06D6744-4072-B679-ECCD-0E9BE4044AAB}"/>
                </a:ext>
              </a:extLst>
            </p:cNvPr>
            <p:cNvSpPr/>
            <p:nvPr/>
          </p:nvSpPr>
          <p:spPr>
            <a:xfrm>
              <a:off x="1064899" y="2135719"/>
              <a:ext cx="457200" cy="2032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  <p:grpSp>
        <p:nvGrpSpPr>
          <p:cNvPr id="40" name="Group 39">
            <a:extLst>
              <a:ext uri="{FF2B5EF4-FFF2-40B4-BE49-F238E27FC236}">
                <a16:creationId xmlns:a16="http://schemas.microsoft.com/office/drawing/2014/main" id="{2A95A94D-8F65-AC8C-D877-50243D36CDBC}"/>
              </a:ext>
            </a:extLst>
          </p:cNvPr>
          <p:cNvGrpSpPr/>
          <p:nvPr/>
        </p:nvGrpSpPr>
        <p:grpSpPr>
          <a:xfrm>
            <a:off x="767720" y="914583"/>
            <a:ext cx="1029971" cy="485564"/>
            <a:chOff x="778513" y="2135719"/>
            <a:chExt cx="1029971" cy="485564"/>
          </a:xfrm>
        </p:grpSpPr>
        <p:sp>
          <p:nvSpPr>
            <p:cNvPr id="41" name="Right Brace 40">
              <a:extLst>
                <a:ext uri="{FF2B5EF4-FFF2-40B4-BE49-F238E27FC236}">
                  <a16:creationId xmlns:a16="http://schemas.microsoft.com/office/drawing/2014/main" id="{52EABE39-280F-1D63-447D-64056E62A774}"/>
                </a:ext>
              </a:extLst>
            </p:cNvPr>
            <p:cNvSpPr/>
            <p:nvPr/>
          </p:nvSpPr>
          <p:spPr>
            <a:xfrm rot="16200000">
              <a:off x="1161247" y="1974045"/>
              <a:ext cx="264504" cy="1029971"/>
            </a:xfrm>
            <a:prstGeom prst="rightBrace">
              <a:avLst>
                <a:gd name="adj1" fmla="val 77381"/>
                <a:gd name="adj2" fmla="val 50000"/>
              </a:avLst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C1A550B1-F01F-CEC1-B545-ED14176D37EF}"/>
                </a:ext>
              </a:extLst>
            </p:cNvPr>
            <p:cNvSpPr/>
            <p:nvPr/>
          </p:nvSpPr>
          <p:spPr>
            <a:xfrm>
              <a:off x="1064899" y="2135719"/>
              <a:ext cx="457200" cy="2032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  <p:grpSp>
        <p:nvGrpSpPr>
          <p:cNvPr id="43" name="Group 42">
            <a:extLst>
              <a:ext uri="{FF2B5EF4-FFF2-40B4-BE49-F238E27FC236}">
                <a16:creationId xmlns:a16="http://schemas.microsoft.com/office/drawing/2014/main" id="{C72C183E-C40C-4D03-F60D-ABD8726AA456}"/>
              </a:ext>
            </a:extLst>
          </p:cNvPr>
          <p:cNvGrpSpPr/>
          <p:nvPr/>
        </p:nvGrpSpPr>
        <p:grpSpPr>
          <a:xfrm>
            <a:off x="2947879" y="909513"/>
            <a:ext cx="1029971" cy="485564"/>
            <a:chOff x="778513" y="2135719"/>
            <a:chExt cx="1029971" cy="485564"/>
          </a:xfrm>
        </p:grpSpPr>
        <p:sp>
          <p:nvSpPr>
            <p:cNvPr id="44" name="Right Brace 43">
              <a:extLst>
                <a:ext uri="{FF2B5EF4-FFF2-40B4-BE49-F238E27FC236}">
                  <a16:creationId xmlns:a16="http://schemas.microsoft.com/office/drawing/2014/main" id="{7059495B-7432-4BB8-885D-7756B092E7D4}"/>
                </a:ext>
              </a:extLst>
            </p:cNvPr>
            <p:cNvSpPr/>
            <p:nvPr/>
          </p:nvSpPr>
          <p:spPr>
            <a:xfrm rot="16200000">
              <a:off x="1161247" y="1974045"/>
              <a:ext cx="264504" cy="1029971"/>
            </a:xfrm>
            <a:prstGeom prst="rightBrace">
              <a:avLst>
                <a:gd name="adj1" fmla="val 77381"/>
                <a:gd name="adj2" fmla="val 50000"/>
              </a:avLst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371DD0A5-DF60-806E-798D-404A282A3607}"/>
                </a:ext>
              </a:extLst>
            </p:cNvPr>
            <p:cNvSpPr/>
            <p:nvPr/>
          </p:nvSpPr>
          <p:spPr>
            <a:xfrm>
              <a:off x="1064899" y="2135719"/>
              <a:ext cx="457200" cy="2032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id="{3B076565-5679-24C8-5B64-BB4E801F7BDF}"/>
              </a:ext>
            </a:extLst>
          </p:cNvPr>
          <p:cNvGrpSpPr/>
          <p:nvPr/>
        </p:nvGrpSpPr>
        <p:grpSpPr>
          <a:xfrm>
            <a:off x="4994162" y="918432"/>
            <a:ext cx="1029971" cy="485564"/>
            <a:chOff x="778513" y="2135719"/>
            <a:chExt cx="1029971" cy="485564"/>
          </a:xfrm>
        </p:grpSpPr>
        <p:sp>
          <p:nvSpPr>
            <p:cNvPr id="47" name="Right Brace 46">
              <a:extLst>
                <a:ext uri="{FF2B5EF4-FFF2-40B4-BE49-F238E27FC236}">
                  <a16:creationId xmlns:a16="http://schemas.microsoft.com/office/drawing/2014/main" id="{FF1C9B6E-2933-6F02-9A37-A02AFE531BD8}"/>
                </a:ext>
              </a:extLst>
            </p:cNvPr>
            <p:cNvSpPr/>
            <p:nvPr/>
          </p:nvSpPr>
          <p:spPr>
            <a:xfrm rot="16200000">
              <a:off x="1161247" y="1974045"/>
              <a:ext cx="264504" cy="1029971"/>
            </a:xfrm>
            <a:prstGeom prst="rightBrace">
              <a:avLst>
                <a:gd name="adj1" fmla="val 77381"/>
                <a:gd name="adj2" fmla="val 50000"/>
              </a:avLst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C7A19661-E875-C464-2E1F-F3607FE6F579}"/>
                </a:ext>
              </a:extLst>
            </p:cNvPr>
            <p:cNvSpPr/>
            <p:nvPr/>
          </p:nvSpPr>
          <p:spPr>
            <a:xfrm>
              <a:off x="1064899" y="2135719"/>
              <a:ext cx="457200" cy="2032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  <p:grpSp>
        <p:nvGrpSpPr>
          <p:cNvPr id="49" name="Group 48">
            <a:extLst>
              <a:ext uri="{FF2B5EF4-FFF2-40B4-BE49-F238E27FC236}">
                <a16:creationId xmlns:a16="http://schemas.microsoft.com/office/drawing/2014/main" id="{AA405D7C-E7AD-6E57-8F4C-9EADCF306BE5}"/>
              </a:ext>
            </a:extLst>
          </p:cNvPr>
          <p:cNvGrpSpPr/>
          <p:nvPr/>
        </p:nvGrpSpPr>
        <p:grpSpPr>
          <a:xfrm>
            <a:off x="903300" y="3983919"/>
            <a:ext cx="1029971" cy="485564"/>
            <a:chOff x="778513" y="2135719"/>
            <a:chExt cx="1029971" cy="485564"/>
          </a:xfrm>
        </p:grpSpPr>
        <p:sp>
          <p:nvSpPr>
            <p:cNvPr id="50" name="Right Brace 49">
              <a:extLst>
                <a:ext uri="{FF2B5EF4-FFF2-40B4-BE49-F238E27FC236}">
                  <a16:creationId xmlns:a16="http://schemas.microsoft.com/office/drawing/2014/main" id="{7851548E-0A9F-51F3-896E-547BF672E7A5}"/>
                </a:ext>
              </a:extLst>
            </p:cNvPr>
            <p:cNvSpPr/>
            <p:nvPr/>
          </p:nvSpPr>
          <p:spPr>
            <a:xfrm rot="16200000">
              <a:off x="1161247" y="1974045"/>
              <a:ext cx="264504" cy="1029971"/>
            </a:xfrm>
            <a:prstGeom prst="rightBrace">
              <a:avLst>
                <a:gd name="adj1" fmla="val 77381"/>
                <a:gd name="adj2" fmla="val 50000"/>
              </a:avLst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F5A6FC4C-25BC-A778-3763-F047F0C13A74}"/>
                </a:ext>
              </a:extLst>
            </p:cNvPr>
            <p:cNvSpPr/>
            <p:nvPr/>
          </p:nvSpPr>
          <p:spPr>
            <a:xfrm>
              <a:off x="1064899" y="2135719"/>
              <a:ext cx="457200" cy="2032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  <p:grpSp>
        <p:nvGrpSpPr>
          <p:cNvPr id="52" name="Group 51">
            <a:extLst>
              <a:ext uri="{FF2B5EF4-FFF2-40B4-BE49-F238E27FC236}">
                <a16:creationId xmlns:a16="http://schemas.microsoft.com/office/drawing/2014/main" id="{A7000BC2-FAD0-1DE5-875C-A7B026DEC3CE}"/>
              </a:ext>
            </a:extLst>
          </p:cNvPr>
          <p:cNvGrpSpPr/>
          <p:nvPr/>
        </p:nvGrpSpPr>
        <p:grpSpPr>
          <a:xfrm>
            <a:off x="9172464" y="918432"/>
            <a:ext cx="1029971" cy="485564"/>
            <a:chOff x="778513" y="2135719"/>
            <a:chExt cx="1029971" cy="485564"/>
          </a:xfrm>
        </p:grpSpPr>
        <p:sp>
          <p:nvSpPr>
            <p:cNvPr id="53" name="Right Brace 52">
              <a:extLst>
                <a:ext uri="{FF2B5EF4-FFF2-40B4-BE49-F238E27FC236}">
                  <a16:creationId xmlns:a16="http://schemas.microsoft.com/office/drawing/2014/main" id="{8080AF89-0EF7-B943-B5A3-8C217F95E27F}"/>
                </a:ext>
              </a:extLst>
            </p:cNvPr>
            <p:cNvSpPr/>
            <p:nvPr/>
          </p:nvSpPr>
          <p:spPr>
            <a:xfrm rot="16200000">
              <a:off x="1161247" y="1974045"/>
              <a:ext cx="264504" cy="1029971"/>
            </a:xfrm>
            <a:prstGeom prst="rightBrace">
              <a:avLst>
                <a:gd name="adj1" fmla="val 77381"/>
                <a:gd name="adj2" fmla="val 50000"/>
              </a:avLst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54" name="Rectangle 53">
              <a:extLst>
                <a:ext uri="{FF2B5EF4-FFF2-40B4-BE49-F238E27FC236}">
                  <a16:creationId xmlns:a16="http://schemas.microsoft.com/office/drawing/2014/main" id="{295FBC54-9835-1E7B-70D1-D1BFE494F26F}"/>
                </a:ext>
              </a:extLst>
            </p:cNvPr>
            <p:cNvSpPr/>
            <p:nvPr/>
          </p:nvSpPr>
          <p:spPr>
            <a:xfrm>
              <a:off x="1064899" y="2135719"/>
              <a:ext cx="457200" cy="2032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  <p:grpSp>
        <p:nvGrpSpPr>
          <p:cNvPr id="55" name="Group 54">
            <a:extLst>
              <a:ext uri="{FF2B5EF4-FFF2-40B4-BE49-F238E27FC236}">
                <a16:creationId xmlns:a16="http://schemas.microsoft.com/office/drawing/2014/main" id="{5EEE6D88-A541-61DA-6A4A-675E3C39FF96}"/>
              </a:ext>
            </a:extLst>
          </p:cNvPr>
          <p:cNvGrpSpPr/>
          <p:nvPr/>
        </p:nvGrpSpPr>
        <p:grpSpPr>
          <a:xfrm>
            <a:off x="7201557" y="3998227"/>
            <a:ext cx="1029971" cy="485564"/>
            <a:chOff x="778513" y="2135719"/>
            <a:chExt cx="1029971" cy="485564"/>
          </a:xfrm>
        </p:grpSpPr>
        <p:sp>
          <p:nvSpPr>
            <p:cNvPr id="56" name="Right Brace 55">
              <a:extLst>
                <a:ext uri="{FF2B5EF4-FFF2-40B4-BE49-F238E27FC236}">
                  <a16:creationId xmlns:a16="http://schemas.microsoft.com/office/drawing/2014/main" id="{2933BCF8-EA64-FF6E-500B-267423145625}"/>
                </a:ext>
              </a:extLst>
            </p:cNvPr>
            <p:cNvSpPr/>
            <p:nvPr/>
          </p:nvSpPr>
          <p:spPr>
            <a:xfrm rot="16200000">
              <a:off x="1161247" y="1974045"/>
              <a:ext cx="264504" cy="1029971"/>
            </a:xfrm>
            <a:prstGeom prst="rightBrace">
              <a:avLst>
                <a:gd name="adj1" fmla="val 77381"/>
                <a:gd name="adj2" fmla="val 50000"/>
              </a:avLst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57" name="Rectangle 56">
              <a:extLst>
                <a:ext uri="{FF2B5EF4-FFF2-40B4-BE49-F238E27FC236}">
                  <a16:creationId xmlns:a16="http://schemas.microsoft.com/office/drawing/2014/main" id="{622F4FF3-DC59-C99D-59C8-A49E48B4829C}"/>
                </a:ext>
              </a:extLst>
            </p:cNvPr>
            <p:cNvSpPr/>
            <p:nvPr/>
          </p:nvSpPr>
          <p:spPr>
            <a:xfrm>
              <a:off x="1064899" y="2135719"/>
              <a:ext cx="457200" cy="2032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  <p:grpSp>
        <p:nvGrpSpPr>
          <p:cNvPr id="58" name="Group 57">
            <a:extLst>
              <a:ext uri="{FF2B5EF4-FFF2-40B4-BE49-F238E27FC236}">
                <a16:creationId xmlns:a16="http://schemas.microsoft.com/office/drawing/2014/main" id="{0108B06B-05D4-FE82-D022-D65CDA4DB704}"/>
              </a:ext>
            </a:extLst>
          </p:cNvPr>
          <p:cNvGrpSpPr/>
          <p:nvPr/>
        </p:nvGrpSpPr>
        <p:grpSpPr>
          <a:xfrm>
            <a:off x="3137116" y="3993105"/>
            <a:ext cx="1029971" cy="485564"/>
            <a:chOff x="778513" y="2135719"/>
            <a:chExt cx="1029971" cy="485564"/>
          </a:xfrm>
        </p:grpSpPr>
        <p:sp>
          <p:nvSpPr>
            <p:cNvPr id="59" name="Right Brace 58">
              <a:extLst>
                <a:ext uri="{FF2B5EF4-FFF2-40B4-BE49-F238E27FC236}">
                  <a16:creationId xmlns:a16="http://schemas.microsoft.com/office/drawing/2014/main" id="{D1E8CDD1-2144-9592-C35F-40AE48462AAB}"/>
                </a:ext>
              </a:extLst>
            </p:cNvPr>
            <p:cNvSpPr/>
            <p:nvPr/>
          </p:nvSpPr>
          <p:spPr>
            <a:xfrm rot="16200000">
              <a:off x="1161247" y="1974045"/>
              <a:ext cx="264504" cy="1029971"/>
            </a:xfrm>
            <a:prstGeom prst="rightBrace">
              <a:avLst>
                <a:gd name="adj1" fmla="val 77381"/>
                <a:gd name="adj2" fmla="val 50000"/>
              </a:avLst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60" name="Rectangle 59">
              <a:extLst>
                <a:ext uri="{FF2B5EF4-FFF2-40B4-BE49-F238E27FC236}">
                  <a16:creationId xmlns:a16="http://schemas.microsoft.com/office/drawing/2014/main" id="{3352C611-78C2-9130-7E88-97B67CB704AB}"/>
                </a:ext>
              </a:extLst>
            </p:cNvPr>
            <p:cNvSpPr/>
            <p:nvPr/>
          </p:nvSpPr>
          <p:spPr>
            <a:xfrm>
              <a:off x="1064899" y="2135719"/>
              <a:ext cx="457200" cy="2032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  <p:grpSp>
        <p:nvGrpSpPr>
          <p:cNvPr id="61" name="Group 60">
            <a:extLst>
              <a:ext uri="{FF2B5EF4-FFF2-40B4-BE49-F238E27FC236}">
                <a16:creationId xmlns:a16="http://schemas.microsoft.com/office/drawing/2014/main" id="{4631A957-455A-45B5-6272-C68403AB7B94}"/>
              </a:ext>
            </a:extLst>
          </p:cNvPr>
          <p:cNvGrpSpPr/>
          <p:nvPr/>
        </p:nvGrpSpPr>
        <p:grpSpPr>
          <a:xfrm>
            <a:off x="4901090" y="4001862"/>
            <a:ext cx="1029971" cy="485564"/>
            <a:chOff x="778513" y="2135719"/>
            <a:chExt cx="1029971" cy="485564"/>
          </a:xfrm>
        </p:grpSpPr>
        <p:sp>
          <p:nvSpPr>
            <p:cNvPr id="62" name="Right Brace 61">
              <a:extLst>
                <a:ext uri="{FF2B5EF4-FFF2-40B4-BE49-F238E27FC236}">
                  <a16:creationId xmlns:a16="http://schemas.microsoft.com/office/drawing/2014/main" id="{2241F908-D2A2-4853-901B-C7D7D9BB2264}"/>
                </a:ext>
              </a:extLst>
            </p:cNvPr>
            <p:cNvSpPr/>
            <p:nvPr/>
          </p:nvSpPr>
          <p:spPr>
            <a:xfrm rot="16200000">
              <a:off x="1161247" y="1974045"/>
              <a:ext cx="264504" cy="1029971"/>
            </a:xfrm>
            <a:prstGeom prst="rightBrace">
              <a:avLst>
                <a:gd name="adj1" fmla="val 77381"/>
                <a:gd name="adj2" fmla="val 50000"/>
              </a:avLst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63" name="Rectangle 62">
              <a:extLst>
                <a:ext uri="{FF2B5EF4-FFF2-40B4-BE49-F238E27FC236}">
                  <a16:creationId xmlns:a16="http://schemas.microsoft.com/office/drawing/2014/main" id="{8DA0CF15-36AD-7A13-D197-D0576BFB1E3D}"/>
                </a:ext>
              </a:extLst>
            </p:cNvPr>
            <p:cNvSpPr/>
            <p:nvPr/>
          </p:nvSpPr>
          <p:spPr>
            <a:xfrm>
              <a:off x="1064899" y="2135719"/>
              <a:ext cx="457200" cy="2032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  <p:grpSp>
        <p:nvGrpSpPr>
          <p:cNvPr id="64" name="Group 63">
            <a:extLst>
              <a:ext uri="{FF2B5EF4-FFF2-40B4-BE49-F238E27FC236}">
                <a16:creationId xmlns:a16="http://schemas.microsoft.com/office/drawing/2014/main" id="{B10BC438-4F8A-5B21-1ACD-887FD1A9E732}"/>
              </a:ext>
            </a:extLst>
          </p:cNvPr>
          <p:cNvGrpSpPr/>
          <p:nvPr/>
        </p:nvGrpSpPr>
        <p:grpSpPr>
          <a:xfrm>
            <a:off x="9065922" y="3987007"/>
            <a:ext cx="1029971" cy="485564"/>
            <a:chOff x="778513" y="2135719"/>
            <a:chExt cx="1029971" cy="485564"/>
          </a:xfrm>
        </p:grpSpPr>
        <p:sp>
          <p:nvSpPr>
            <p:cNvPr id="65" name="Right Brace 64">
              <a:extLst>
                <a:ext uri="{FF2B5EF4-FFF2-40B4-BE49-F238E27FC236}">
                  <a16:creationId xmlns:a16="http://schemas.microsoft.com/office/drawing/2014/main" id="{7B690986-18C7-7100-F442-14EBAFE71E36}"/>
                </a:ext>
              </a:extLst>
            </p:cNvPr>
            <p:cNvSpPr/>
            <p:nvPr/>
          </p:nvSpPr>
          <p:spPr>
            <a:xfrm rot="16200000">
              <a:off x="1161247" y="1974045"/>
              <a:ext cx="264504" cy="1029971"/>
            </a:xfrm>
            <a:prstGeom prst="rightBrace">
              <a:avLst>
                <a:gd name="adj1" fmla="val 77381"/>
                <a:gd name="adj2" fmla="val 50000"/>
              </a:avLst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7DB44BB4-878B-FBDC-569B-A1590E4F4ED1}"/>
                </a:ext>
              </a:extLst>
            </p:cNvPr>
            <p:cNvSpPr/>
            <p:nvPr/>
          </p:nvSpPr>
          <p:spPr>
            <a:xfrm>
              <a:off x="1064899" y="2135719"/>
              <a:ext cx="457200" cy="2032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  <p:pic>
        <p:nvPicPr>
          <p:cNvPr id="2" name="Picture 1">
            <a:extLst>
              <a:ext uri="{FF2B5EF4-FFF2-40B4-BE49-F238E27FC236}">
                <a16:creationId xmlns:a16="http://schemas.microsoft.com/office/drawing/2014/main" id="{49837212-B0F7-A2CD-9D2F-88785D3C3406}"/>
              </a:ext>
            </a:extLst>
          </p:cNvPr>
          <p:cNvPicPr>
            <a:picLocks noChangeAspect="1"/>
          </p:cNvPicPr>
          <p:nvPr/>
        </p:nvPicPr>
        <p:blipFill>
          <a:blip r:embed="rId13"/>
          <a:srcRect l="75570" t="18707" r="1734" b="44542"/>
          <a:stretch/>
        </p:blipFill>
        <p:spPr>
          <a:xfrm>
            <a:off x="10561075" y="1412753"/>
            <a:ext cx="1389071" cy="121973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5496C84-2FD8-6435-81D9-70B9E98E6CD4}"/>
              </a:ext>
            </a:extLst>
          </p:cNvPr>
          <p:cNvSpPr txBox="1"/>
          <p:nvPr/>
        </p:nvSpPr>
        <p:spPr>
          <a:xfrm>
            <a:off x="0" y="0"/>
            <a:ext cx="82671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/>
              <a:t>Fig. S3</a:t>
            </a:r>
            <a:endParaRPr lang="en-US" sz="2400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9C3A71B-A38B-F152-8D98-A2FBF54600A1}"/>
              </a:ext>
            </a:extLst>
          </p:cNvPr>
          <p:cNvSpPr txBox="1"/>
          <p:nvPr/>
        </p:nvSpPr>
        <p:spPr>
          <a:xfrm>
            <a:off x="159562" y="6474327"/>
            <a:ext cx="1189472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 defTabSz="914400">
              <a:defRPr/>
            </a:pP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</a:rPr>
              <a:t>Fig</a:t>
            </a: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</a:rPr>
              <a:t>. S3: 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</a:rPr>
              <a:t>Baseline cytokine secretion in vehicle-treated PBMCs</a:t>
            </a:r>
            <a:r>
              <a:rPr lang="en-US" sz="1200" kern="100" dirty="0">
                <a:solidFill>
                  <a:srgbClr val="FF0000"/>
                </a:solidFill>
                <a:latin typeface="Arial" panose="020B0604020202020204" pitchFamily="34" charset="0"/>
                <a:ea typeface="Aptos" panose="020B0004020202020204" pitchFamily="34" charset="0"/>
              </a:rPr>
              <a:t>. 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ar graphs overlaid with scatter plots showing secretion of inflammatory cytokines from unstimulated PBMCs after 24h from NHCs, </a:t>
            </a:r>
            <a:r>
              <a:rPr lang="en-US" sz="1200" kern="100" dirty="0" err="1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PD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patients, </a:t>
            </a:r>
            <a:r>
              <a:rPr lang="en-US" sz="1200" i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LRRK2-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D patients, and </a:t>
            </a:r>
            <a:r>
              <a:rPr lang="en-US" sz="1200" i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BA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-PD patients. (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Secretion of IFN‐</a:t>
            </a:r>
            <a:r>
              <a:rPr lang="el-GR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γ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(Cohort </a:t>
            </a:r>
            <a:r>
              <a:rPr lang="en-US" sz="1200" i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5862). (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Secretion of IL-10 (Cohort </a:t>
            </a:r>
            <a:r>
              <a:rPr lang="en-US" sz="1200" i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7260). (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Secretion of IL-12p70 (Cohort </a:t>
            </a:r>
            <a:r>
              <a:rPr lang="en-US" sz="1200" i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0377). (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D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Secretion of IL-13 (Cohort </a:t>
            </a:r>
            <a:r>
              <a:rPr lang="en-US" sz="1200" i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8943). (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E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Secretion of IL-1β (Cohort </a:t>
            </a:r>
            <a:r>
              <a:rPr lang="en-US" sz="1200" i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2654). (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Secretion of IL-2 (Cohort </a:t>
            </a:r>
            <a:r>
              <a:rPr lang="en-US" sz="1200" i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3061). (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Secretion of IL-4 (Cohort </a:t>
            </a:r>
            <a:r>
              <a:rPr lang="en-US" sz="1200" i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1340). (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H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Secretion of IL-6 (Cohort </a:t>
            </a:r>
            <a:r>
              <a:rPr lang="en-US" sz="1200" i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0559). (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Secretion of IL-8 (Cohort </a:t>
            </a:r>
            <a:r>
              <a:rPr lang="en-US" sz="1200" i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6352). (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J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Secretion of TNF (Cohort </a:t>
            </a:r>
            <a:r>
              <a:rPr lang="en-US" sz="1200" i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2755). Bars represent mean +/- SEM. NHCs, </a:t>
            </a:r>
            <a:r>
              <a:rPr lang="en-US" sz="1200" i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 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= 35; </a:t>
            </a:r>
            <a:r>
              <a:rPr lang="en-US" sz="1200" kern="100" dirty="0" err="1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PD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, </a:t>
            </a:r>
            <a:r>
              <a:rPr lang="en-US" sz="1200" i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28; </a:t>
            </a:r>
            <a:r>
              <a:rPr lang="en-US" sz="1200" i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LRRK2-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D, </a:t>
            </a:r>
            <a:r>
              <a:rPr lang="en-US" sz="1200" i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11; </a:t>
            </a:r>
            <a:r>
              <a:rPr lang="en-US" sz="1200" i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BA-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D, </a:t>
            </a:r>
            <a:r>
              <a:rPr lang="en-US" sz="1200" i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16. Each symbol represents the measurement from a single individual. The results in A-J were analyzed using one-way ANOVA with Tukey’s corrections for multiple comparisons. 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tatistically significant differences between cohorts defined by 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&lt; 0.05 are shown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endParaRPr lang="en-US" sz="1200" kern="100" dirty="0">
              <a:latin typeface="Arial" panose="020B06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29878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680</TotalTime>
  <Words>486</Words>
  <Application>Microsoft Office PowerPoint</Application>
  <PresentationFormat>Custom</PresentationFormat>
  <Paragraphs>2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LRRK2/GBA1 mutations peripheral immune cells in Parkinson’s disease</dc:title>
  <dc:creator>Julian Mark</dc:creator>
  <cp:lastModifiedBy>Mark, Julian</cp:lastModifiedBy>
  <cp:revision>827</cp:revision>
  <dcterms:created xsi:type="dcterms:W3CDTF">2025-01-19T15:31:25Z</dcterms:created>
  <dcterms:modified xsi:type="dcterms:W3CDTF">2025-10-25T20:19:04Z</dcterms:modified>
</cp:coreProperties>
</file>